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4"/>
  </p:sldMasterIdLst>
  <p:sldIdLst>
    <p:sldId id="256" r:id="rId5"/>
  </p:sldIdLst>
  <p:sldSz cx="12192000" cy="73152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82" d="100"/>
          <a:sy n="82" d="100"/>
        </p:scale>
        <p:origin x="720" y="67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customXml" Target="../customXml/item3.xml"/><Relationship Id="rId7" Type="http://schemas.openxmlformats.org/officeDocument/2006/relationships/viewProps" Target="viewProps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presProps" Target="presProps.xml"/><Relationship Id="rId5" Type="http://schemas.openxmlformats.org/officeDocument/2006/relationships/slide" Target="slides/slide1.xml"/><Relationship Id="rId4" Type="http://schemas.openxmlformats.org/officeDocument/2006/relationships/slideMaster" Target="slideMasters/slideMaster1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97187"/>
            <a:ext cx="9144000" cy="2546773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842174"/>
            <a:ext cx="9144000" cy="1766146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EB4888-C4AF-468F-82C7-AC4AEE5BF0FC}" type="datetimeFigureOut">
              <a:rPr lang="en-US" smtClean="0"/>
              <a:t>5/1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AE698B-CEA9-4785-8BCE-39E6374F449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1116555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EB4888-C4AF-468F-82C7-AC4AEE5BF0FC}" type="datetimeFigureOut">
              <a:rPr lang="en-US" smtClean="0"/>
              <a:t>5/1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AE698B-CEA9-4785-8BCE-39E6374F449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5321997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89467"/>
            <a:ext cx="2628900" cy="6199294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89467"/>
            <a:ext cx="7734300" cy="6199294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EB4888-C4AF-468F-82C7-AC4AEE5BF0FC}" type="datetimeFigureOut">
              <a:rPr lang="en-US" smtClean="0"/>
              <a:t>5/1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AE698B-CEA9-4785-8BCE-39E6374F449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3008179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EB4888-C4AF-468F-82C7-AC4AEE5BF0FC}" type="datetimeFigureOut">
              <a:rPr lang="en-US" smtClean="0"/>
              <a:t>5/1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AE698B-CEA9-4785-8BCE-39E6374F449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9111498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823721"/>
            <a:ext cx="10515600" cy="3042919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895428"/>
            <a:ext cx="10515600" cy="1600199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EB4888-C4AF-468F-82C7-AC4AEE5BF0FC}" type="datetimeFigureOut">
              <a:rPr lang="en-US" smtClean="0"/>
              <a:t>5/1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AE698B-CEA9-4785-8BCE-39E6374F449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6911599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947333"/>
            <a:ext cx="5181600" cy="4641427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947333"/>
            <a:ext cx="5181600" cy="4641427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EB4888-C4AF-468F-82C7-AC4AEE5BF0FC}" type="datetimeFigureOut">
              <a:rPr lang="en-US" smtClean="0"/>
              <a:t>5/1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AE698B-CEA9-4785-8BCE-39E6374F449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3440899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89467"/>
            <a:ext cx="10515600" cy="1413934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9" y="1793241"/>
            <a:ext cx="5157787" cy="878839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9" y="2672080"/>
            <a:ext cx="5157787" cy="3930227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793241"/>
            <a:ext cx="5183188" cy="878839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672080"/>
            <a:ext cx="5183188" cy="3930227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EB4888-C4AF-468F-82C7-AC4AEE5BF0FC}" type="datetimeFigureOut">
              <a:rPr lang="en-US" smtClean="0"/>
              <a:t>5/1/2021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AE698B-CEA9-4785-8BCE-39E6374F449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924751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EB4888-C4AF-468F-82C7-AC4AEE5BF0FC}" type="datetimeFigureOut">
              <a:rPr lang="en-US" smtClean="0"/>
              <a:t>5/1/2021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AE698B-CEA9-4785-8BCE-39E6374F449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2622116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EB4888-C4AF-468F-82C7-AC4AEE5BF0FC}" type="datetimeFigureOut">
              <a:rPr lang="en-US" smtClean="0"/>
              <a:t>5/1/2021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AE698B-CEA9-4785-8BCE-39E6374F449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0727488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9" y="487680"/>
            <a:ext cx="3932237" cy="170688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1053254"/>
            <a:ext cx="6172200" cy="519853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9" y="2194560"/>
            <a:ext cx="3932237" cy="4065694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EB4888-C4AF-468F-82C7-AC4AEE5BF0FC}" type="datetimeFigureOut">
              <a:rPr lang="en-US" smtClean="0"/>
              <a:t>5/1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AE698B-CEA9-4785-8BCE-39E6374F449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3447830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9" y="487680"/>
            <a:ext cx="3932237" cy="170688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5183188" y="1053254"/>
            <a:ext cx="6172200" cy="5198533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9" y="2194560"/>
            <a:ext cx="3932237" cy="4065694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EB4888-C4AF-468F-82C7-AC4AEE5BF0FC}" type="datetimeFigureOut">
              <a:rPr lang="en-US" smtClean="0"/>
              <a:t>5/1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AE698B-CEA9-4785-8BCE-39E6374F449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8086679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89467"/>
            <a:ext cx="10515600" cy="1413934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947333"/>
            <a:ext cx="10515600" cy="464142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780107"/>
            <a:ext cx="2743200" cy="38946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CEB4888-C4AF-468F-82C7-AC4AEE5BF0FC}" type="datetimeFigureOut">
              <a:rPr lang="en-US" smtClean="0"/>
              <a:t>5/1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780107"/>
            <a:ext cx="4114800" cy="38946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780107"/>
            <a:ext cx="2743200" cy="38946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EAE698B-CEA9-4785-8BCE-39E6374F449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547454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0" y="-18662"/>
            <a:ext cx="4236098" cy="220081"/>
          </a:xfrm>
        </p:spPr>
        <p:txBody>
          <a:bodyPr>
            <a:noAutofit/>
          </a:bodyPr>
          <a:lstStyle/>
          <a:p>
            <a:pPr algn="l"/>
            <a:r>
              <a:rPr lang="en-US" sz="1100" dirty="0" smtClean="0"/>
              <a:t>Supplementary Table </a:t>
            </a:r>
            <a:r>
              <a:rPr lang="en-US" sz="1100" dirty="0"/>
              <a:t>S1. Metadata of the mock fungal community</a:t>
            </a:r>
          </a:p>
        </p:txBody>
      </p:sp>
      <p:graphicFrame>
        <p:nvGraphicFramePr>
          <p:cNvPr id="11" name="Table 10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731322954"/>
              </p:ext>
            </p:extLst>
          </p:nvPr>
        </p:nvGraphicFramePr>
        <p:xfrm>
          <a:off x="2" y="201419"/>
          <a:ext cx="12192001" cy="7111847"/>
        </p:xfrm>
        <a:graphic>
          <a:graphicData uri="http://schemas.openxmlformats.org/drawingml/2006/table">
            <a:tbl>
              <a:tblPr/>
              <a:tblGrid>
                <a:gridCol w="1254034">
                  <a:extLst>
                    <a:ext uri="{9D8B030D-6E8A-4147-A177-3AD203B41FA5}">
                      <a16:colId xmlns:a16="http://schemas.microsoft.com/office/drawing/2014/main" val="2203783154"/>
                    </a:ext>
                  </a:extLst>
                </a:gridCol>
                <a:gridCol w="1428206">
                  <a:extLst>
                    <a:ext uri="{9D8B030D-6E8A-4147-A177-3AD203B41FA5}">
                      <a16:colId xmlns:a16="http://schemas.microsoft.com/office/drawing/2014/main" val="3295571978"/>
                    </a:ext>
                  </a:extLst>
                </a:gridCol>
                <a:gridCol w="1445623">
                  <a:extLst>
                    <a:ext uri="{9D8B030D-6E8A-4147-A177-3AD203B41FA5}">
                      <a16:colId xmlns:a16="http://schemas.microsoft.com/office/drawing/2014/main" val="939060147"/>
                    </a:ext>
                  </a:extLst>
                </a:gridCol>
                <a:gridCol w="1062446">
                  <a:extLst>
                    <a:ext uri="{9D8B030D-6E8A-4147-A177-3AD203B41FA5}">
                      <a16:colId xmlns:a16="http://schemas.microsoft.com/office/drawing/2014/main" val="198849107"/>
                    </a:ext>
                  </a:extLst>
                </a:gridCol>
                <a:gridCol w="1045028">
                  <a:extLst>
                    <a:ext uri="{9D8B030D-6E8A-4147-A177-3AD203B41FA5}">
                      <a16:colId xmlns:a16="http://schemas.microsoft.com/office/drawing/2014/main" val="2124871828"/>
                    </a:ext>
                  </a:extLst>
                </a:gridCol>
                <a:gridCol w="3065417">
                  <a:extLst>
                    <a:ext uri="{9D8B030D-6E8A-4147-A177-3AD203B41FA5}">
                      <a16:colId xmlns:a16="http://schemas.microsoft.com/office/drawing/2014/main" val="903136539"/>
                    </a:ext>
                  </a:extLst>
                </a:gridCol>
                <a:gridCol w="2891247">
                  <a:extLst>
                    <a:ext uri="{9D8B030D-6E8A-4147-A177-3AD203B41FA5}">
                      <a16:colId xmlns:a16="http://schemas.microsoft.com/office/drawing/2014/main" val="2121886871"/>
                    </a:ext>
                  </a:extLst>
                </a:gridCol>
              </a:tblGrid>
              <a:tr h="223112"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enus</a:t>
                      </a:r>
                    </a:p>
                  </a:txBody>
                  <a:tcPr marL="3858" marR="3858" marT="385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pecies name</a:t>
                      </a:r>
                    </a:p>
                  </a:txBody>
                  <a:tcPr marL="3858" marR="3858" marT="385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equenced strain/isolate</a:t>
                      </a:r>
                    </a:p>
                  </a:txBody>
                  <a:tcPr marL="3858" marR="3858" marT="385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ssembly level</a:t>
                      </a:r>
                    </a:p>
                  </a:txBody>
                  <a:tcPr marL="3858" marR="3858" marT="385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ccession</a:t>
                      </a:r>
                    </a:p>
                  </a:txBody>
                  <a:tcPr marL="3858" marR="3858" marT="385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File name</a:t>
                      </a:r>
                    </a:p>
                  </a:txBody>
                  <a:tcPr marL="3858" marR="3858" marT="385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ote</a:t>
                      </a:r>
                    </a:p>
                  </a:txBody>
                  <a:tcPr marL="3858" marR="3858" marT="385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872509584"/>
                  </a:ext>
                </a:extLst>
              </a:tr>
              <a:tr h="146733">
                <a:tc rowSpan="2"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spergillus</a:t>
                      </a:r>
                    </a:p>
                  </a:txBody>
                  <a:tcPr marL="3858" marR="3858" marT="385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Aspergillus flavus</a:t>
                      </a:r>
                    </a:p>
                  </a:txBody>
                  <a:tcPr marL="3858" marR="3858" marT="385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RRL3357</a:t>
                      </a:r>
                    </a:p>
                  </a:txBody>
                  <a:tcPr marL="3858" marR="3858" marT="385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caffold</a:t>
                      </a:r>
                    </a:p>
                  </a:txBody>
                  <a:tcPr marL="3858" marR="3858" marT="385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CF_000006275.2</a:t>
                      </a:r>
                    </a:p>
                  </a:txBody>
                  <a:tcPr marL="3858" marR="3858" marT="385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CF_000006275.2_JCVI-afl1-v2.0_genomic.fna.gz</a:t>
                      </a:r>
                    </a:p>
                  </a:txBody>
                  <a:tcPr marL="3858" marR="3858" marT="385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3858" marR="3858" marT="385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892574493"/>
                  </a:ext>
                </a:extLst>
              </a:tr>
              <a:tr h="146733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Aspergillus fumigatus</a:t>
                      </a:r>
                    </a:p>
                  </a:txBody>
                  <a:tcPr marL="3858" marR="3858" marT="385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f293</a:t>
                      </a:r>
                    </a:p>
                  </a:txBody>
                  <a:tcPr marL="3858" marR="3858" marT="385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hromosome</a:t>
                      </a:r>
                    </a:p>
                  </a:txBody>
                  <a:tcPr marL="3858" marR="3858" marT="385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CF_000002655.1</a:t>
                      </a:r>
                    </a:p>
                  </a:txBody>
                  <a:tcPr marL="3858" marR="3858" marT="385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CF_000002655.1_ASM265v1_genomic.fna.gz</a:t>
                      </a:r>
                    </a:p>
                  </a:txBody>
                  <a:tcPr marL="3858" marR="3858" marT="385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3858" marR="3858" marT="385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34039936"/>
                  </a:ext>
                </a:extLst>
              </a:tr>
              <a:tr h="146733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Blastobotrys</a:t>
                      </a:r>
                    </a:p>
                  </a:txBody>
                  <a:tcPr marL="3858" marR="3858" marT="385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Blastobotrys proliferans</a:t>
                      </a:r>
                    </a:p>
                  </a:txBody>
                  <a:tcPr marL="3858" marR="3858" marT="385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RRL Y-17577</a:t>
                      </a:r>
                    </a:p>
                  </a:txBody>
                  <a:tcPr marL="3858" marR="3858" marT="385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caffold</a:t>
                      </a:r>
                    </a:p>
                  </a:txBody>
                  <a:tcPr marL="3858" marR="3858" marT="385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CA_003707485.2</a:t>
                      </a:r>
                    </a:p>
                  </a:txBody>
                  <a:tcPr marL="3858" marR="3858" marT="385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CA_003707485.2_ASM370748v2_genomic.fna.gz</a:t>
                      </a:r>
                    </a:p>
                  </a:txBody>
                  <a:tcPr marL="3858" marR="3858" marT="385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3858" marR="3858" marT="385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573934285"/>
                  </a:ext>
                </a:extLst>
              </a:tr>
              <a:tr h="146733">
                <a:tc rowSpan="9"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andida</a:t>
                      </a:r>
                    </a:p>
                  </a:txBody>
                  <a:tcPr marL="3858" marR="3858" marT="385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andida albicans</a:t>
                      </a:r>
                    </a:p>
                  </a:txBody>
                  <a:tcPr marL="3858" marR="3858" marT="385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C5314</a:t>
                      </a:r>
                    </a:p>
                  </a:txBody>
                  <a:tcPr marL="3858" marR="3858" marT="385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hromosome</a:t>
                      </a:r>
                    </a:p>
                  </a:txBody>
                  <a:tcPr marL="3858" marR="3858" marT="385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CA_000182965.3</a:t>
                      </a:r>
                    </a:p>
                  </a:txBody>
                  <a:tcPr marL="3858" marR="3858" marT="385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CA_000182965.3_ASM18296v3_genomic.fna.gz</a:t>
                      </a:r>
                    </a:p>
                  </a:txBody>
                  <a:tcPr marL="3858" marR="3858" marT="385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3858" marR="3858" marT="385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267300500"/>
                  </a:ext>
                </a:extLst>
              </a:tr>
              <a:tr h="146733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andida(Diutina) catenulata</a:t>
                      </a:r>
                    </a:p>
                  </a:txBody>
                  <a:tcPr marL="3858" marR="3858" marT="385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WY3-10-4</a:t>
                      </a:r>
                    </a:p>
                  </a:txBody>
                  <a:tcPr marL="3858" marR="3858" marT="385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ontig</a:t>
                      </a:r>
                    </a:p>
                  </a:txBody>
                  <a:tcPr marL="3858" marR="3858" marT="385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CA_003285555.1</a:t>
                      </a:r>
                    </a:p>
                  </a:txBody>
                  <a:tcPr marL="3858" marR="3858" marT="385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CA_003285555.1_ASM328555v1_genomic.fna.gz</a:t>
                      </a:r>
                    </a:p>
                  </a:txBody>
                  <a:tcPr marL="3858" marR="3858" marT="385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3858" marR="3858" marT="385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76517907"/>
                  </a:ext>
                </a:extLst>
              </a:tr>
              <a:tr h="146733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andida dubliniensis</a:t>
                      </a:r>
                    </a:p>
                  </a:txBody>
                  <a:tcPr marL="3858" marR="3858" marT="385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D36</a:t>
                      </a:r>
                    </a:p>
                  </a:txBody>
                  <a:tcPr marL="3858" marR="3858" marT="385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hromosome</a:t>
                      </a:r>
                    </a:p>
                  </a:txBody>
                  <a:tcPr marL="3858" marR="3858" marT="385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CA_000026945.1</a:t>
                      </a:r>
                    </a:p>
                  </a:txBody>
                  <a:tcPr marL="3858" marR="3858" marT="385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CA_000026945.1_ASM2694v1_genomic.fna.gz</a:t>
                      </a:r>
                    </a:p>
                  </a:txBody>
                  <a:tcPr marL="3858" marR="3858" marT="385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3858" marR="3858" marT="385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966811945"/>
                  </a:ext>
                </a:extLst>
              </a:tr>
              <a:tr h="146733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andida glabrata</a:t>
                      </a:r>
                    </a:p>
                  </a:txBody>
                  <a:tcPr marL="3858" marR="3858" marT="385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BS 138</a:t>
                      </a:r>
                    </a:p>
                  </a:txBody>
                  <a:tcPr marL="3858" marR="3858" marT="385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hromosome</a:t>
                      </a:r>
                    </a:p>
                  </a:txBody>
                  <a:tcPr marL="3858" marR="3858" marT="385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CF_000002545.3</a:t>
                      </a:r>
                    </a:p>
                  </a:txBody>
                  <a:tcPr marL="3858" marR="3858" marT="385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CF_000002545.3_ASM254v2_genomic.fna.gz</a:t>
                      </a:r>
                    </a:p>
                  </a:txBody>
                  <a:tcPr marL="3858" marR="3858" marT="385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3858" marR="3858" marT="385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685531897"/>
                  </a:ext>
                </a:extLst>
              </a:tr>
              <a:tr h="146733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andida haemulonis</a:t>
                      </a:r>
                    </a:p>
                  </a:txBody>
                  <a:tcPr marL="3858" marR="3858" marT="385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B11899</a:t>
                      </a:r>
                    </a:p>
                  </a:txBody>
                  <a:tcPr marL="3858" marR="3858" marT="385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ontig</a:t>
                      </a:r>
                    </a:p>
                  </a:txBody>
                  <a:tcPr marL="3858" marR="3858" marT="385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CF_002926055.2</a:t>
                      </a:r>
                    </a:p>
                  </a:txBody>
                  <a:tcPr marL="3858" marR="3858" marT="385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CF_002926055.2_CanHae_1.0_genomic.fna.gz</a:t>
                      </a:r>
                    </a:p>
                  </a:txBody>
                  <a:tcPr marL="3858" marR="3858" marT="385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3858" marR="3858" marT="385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569737668"/>
                  </a:ext>
                </a:extLst>
              </a:tr>
              <a:tr h="146733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andida mesorugosa</a:t>
                      </a:r>
                    </a:p>
                  </a:txBody>
                  <a:tcPr marL="3858" marR="3858" marT="385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3858" marR="3858" marT="385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3858" marR="3858" marT="385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3858" marR="3858" marT="385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3858" marR="3858" marT="385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locally assembled, taxid 1229076</a:t>
                      </a:r>
                    </a:p>
                  </a:txBody>
                  <a:tcPr marL="3858" marR="3858" marT="385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55866006"/>
                  </a:ext>
                </a:extLst>
              </a:tr>
              <a:tr h="146733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andida parapsilosis</a:t>
                      </a:r>
                    </a:p>
                  </a:txBody>
                  <a:tcPr marL="3858" marR="3858" marT="385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DC317</a:t>
                      </a:r>
                    </a:p>
                  </a:txBody>
                  <a:tcPr marL="3858" marR="3858" marT="385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caffold</a:t>
                      </a:r>
                    </a:p>
                  </a:txBody>
                  <a:tcPr marL="3858" marR="3858" marT="385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CA_000182765.2</a:t>
                      </a:r>
                    </a:p>
                  </a:txBody>
                  <a:tcPr marL="3858" marR="3858" marT="385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CA_000182765.2_ASM18276v2_genomic.fna.gz</a:t>
                      </a:r>
                    </a:p>
                  </a:txBody>
                  <a:tcPr marL="3858" marR="3858" marT="385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3858" marR="3858" marT="385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880162997"/>
                  </a:ext>
                </a:extLst>
              </a:tr>
              <a:tr h="146733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andida rugosa</a:t>
                      </a:r>
                    </a:p>
                  </a:txBody>
                  <a:tcPr marL="3858" marR="3858" marT="385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3858" marR="3858" marT="385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3858" marR="3858" marT="385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3858" marR="3858" marT="385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3858" marR="3858" marT="385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locally assembled, taxid 5481</a:t>
                      </a:r>
                    </a:p>
                  </a:txBody>
                  <a:tcPr marL="3858" marR="3858" marT="385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07971515"/>
                  </a:ext>
                </a:extLst>
              </a:tr>
              <a:tr h="146733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andida tropicalis</a:t>
                      </a:r>
                    </a:p>
                  </a:txBody>
                  <a:tcPr marL="3858" marR="3858" marT="385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YA-3404</a:t>
                      </a:r>
                    </a:p>
                  </a:txBody>
                  <a:tcPr marL="3858" marR="3858" marT="385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caffold</a:t>
                      </a:r>
                    </a:p>
                  </a:txBody>
                  <a:tcPr marL="3858" marR="3858" marT="385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CF_000006335.3</a:t>
                      </a:r>
                    </a:p>
                  </a:txBody>
                  <a:tcPr marL="3858" marR="3858" marT="385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CF_000006335.3_ASM633v3_genomic.fna.gz</a:t>
                      </a:r>
                    </a:p>
                  </a:txBody>
                  <a:tcPr marL="3858" marR="3858" marT="385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3858" marR="3858" marT="385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308760256"/>
                  </a:ext>
                </a:extLst>
              </a:tr>
              <a:tr h="146733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lavispora</a:t>
                      </a:r>
                    </a:p>
                  </a:txBody>
                  <a:tcPr marL="3858" marR="3858" marT="385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lavispora lusitaniae</a:t>
                      </a:r>
                    </a:p>
                  </a:txBody>
                  <a:tcPr marL="3858" marR="3858" marT="385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TCC 42720</a:t>
                      </a:r>
                    </a:p>
                  </a:txBody>
                  <a:tcPr marL="3858" marR="3858" marT="385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caffold</a:t>
                      </a:r>
                    </a:p>
                  </a:txBody>
                  <a:tcPr marL="3858" marR="3858" marT="385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CF_000003835.1</a:t>
                      </a:r>
                    </a:p>
                  </a:txBody>
                  <a:tcPr marL="3858" marR="3858" marT="385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CF_000003835.1_ASM383v1_genomic.fna.gz</a:t>
                      </a:r>
                    </a:p>
                  </a:txBody>
                  <a:tcPr marL="3858" marR="3858" marT="385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3858" marR="3858" marT="385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862872688"/>
                  </a:ext>
                </a:extLst>
              </a:tr>
              <a:tr h="289608">
                <a:tc rowSpan="9"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ryptococcus</a:t>
                      </a:r>
                    </a:p>
                  </a:txBody>
                  <a:tcPr marL="3858" marR="3858" marT="385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ryptococcus albidus</a:t>
                      </a:r>
                    </a:p>
                  </a:txBody>
                  <a:tcPr marL="3858" marR="3858" marT="385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JCM 2334</a:t>
                      </a:r>
                    </a:p>
                  </a:txBody>
                  <a:tcPr marL="3858" marR="3858" marT="385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caffold</a:t>
                      </a:r>
                    </a:p>
                  </a:txBody>
                  <a:tcPr marL="3858" marR="3858" marT="385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CA_001599735.1</a:t>
                      </a:r>
                    </a:p>
                  </a:txBody>
                  <a:tcPr marL="3858" marR="3858" marT="385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CA_001599735.1_JCM_2334_assembly_v001_genomic.fna.gz</a:t>
                      </a:r>
                    </a:p>
                  </a:txBody>
                  <a:tcPr marL="3858" marR="3858" marT="385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3858" marR="3858" marT="385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55731808"/>
                  </a:ext>
                </a:extLst>
              </a:tr>
              <a:tr h="146733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ryptococcus gattii</a:t>
                      </a:r>
                    </a:p>
                  </a:txBody>
                  <a:tcPr marL="3858" marR="3858" marT="385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WM276</a:t>
                      </a:r>
                    </a:p>
                  </a:txBody>
                  <a:tcPr marL="3858" marR="3858" marT="385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hromosome</a:t>
                      </a:r>
                    </a:p>
                  </a:txBody>
                  <a:tcPr marL="3858" marR="3858" marT="385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CF_000185945.1</a:t>
                      </a:r>
                    </a:p>
                  </a:txBody>
                  <a:tcPr marL="3858" marR="3858" marT="385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CA_000185945.1_ASM18594v1_genomic.fna.gz</a:t>
                      </a:r>
                    </a:p>
                  </a:txBody>
                  <a:tcPr marL="3858" marR="3858" marT="385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3858" marR="3858" marT="385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301184843"/>
                  </a:ext>
                </a:extLst>
              </a:tr>
              <a:tr h="146733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ryptococcus gattii</a:t>
                      </a:r>
                    </a:p>
                  </a:txBody>
                  <a:tcPr marL="3858" marR="3858" marT="385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R265</a:t>
                      </a:r>
                    </a:p>
                  </a:txBody>
                  <a:tcPr marL="3858" marR="3858" marT="385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caffold</a:t>
                      </a:r>
                    </a:p>
                  </a:txBody>
                  <a:tcPr marL="3858" marR="3858" marT="385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CA_000786445.1</a:t>
                      </a:r>
                    </a:p>
                  </a:txBody>
                  <a:tcPr marL="3858" marR="3858" marT="385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CA_000786445.1_R265.1_genomic.fna.gz</a:t>
                      </a:r>
                    </a:p>
                  </a:txBody>
                  <a:tcPr marL="3858" marR="3858" marT="385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3858" marR="3858" marT="385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533481013"/>
                  </a:ext>
                </a:extLst>
              </a:tr>
              <a:tr h="146733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ryptococcus gattii</a:t>
                      </a:r>
                    </a:p>
                  </a:txBody>
                  <a:tcPr marL="3858" marR="3858" marT="385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WM276</a:t>
                      </a:r>
                    </a:p>
                  </a:txBody>
                  <a:tcPr marL="3858" marR="3858" marT="385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hromosome</a:t>
                      </a:r>
                    </a:p>
                  </a:txBody>
                  <a:tcPr marL="3858" marR="3858" marT="385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CF_000185945.1</a:t>
                      </a:r>
                    </a:p>
                  </a:txBody>
                  <a:tcPr marL="3858" marR="3858" marT="385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CA_000185945.1_ASM18594v1_genomic.fna.gz</a:t>
                      </a:r>
                    </a:p>
                  </a:txBody>
                  <a:tcPr marL="3858" marR="3858" marT="385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3858" marR="3858" marT="385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725769391"/>
                  </a:ext>
                </a:extLst>
              </a:tr>
              <a:tr h="146733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ryptococcus gattii</a:t>
                      </a:r>
                    </a:p>
                  </a:txBody>
                  <a:tcPr marL="3858" marR="3858" marT="385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R265</a:t>
                      </a:r>
                    </a:p>
                  </a:txBody>
                  <a:tcPr marL="3858" marR="3858" marT="385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caffold</a:t>
                      </a:r>
                    </a:p>
                  </a:txBody>
                  <a:tcPr marL="3858" marR="3858" marT="385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CA_000786445.1</a:t>
                      </a:r>
                    </a:p>
                  </a:txBody>
                  <a:tcPr marL="3858" marR="3858" marT="385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CA_000786445.1_R265.1_genomic.fna.gz</a:t>
                      </a:r>
                    </a:p>
                  </a:txBody>
                  <a:tcPr marL="3858" marR="3858" marT="385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3858" marR="3858" marT="385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379010966"/>
                  </a:ext>
                </a:extLst>
              </a:tr>
              <a:tr h="146733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ryptococcus magnus</a:t>
                      </a:r>
                    </a:p>
                  </a:txBody>
                  <a:tcPr marL="3858" marR="3858" marT="385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3858" marR="3858" marT="385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3858" marR="3858" marT="385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3858" marR="3858" marT="385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3858" marR="3858" marT="385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locally assembled, taxid 104409</a:t>
                      </a:r>
                    </a:p>
                  </a:txBody>
                  <a:tcPr marL="3858" marR="3858" marT="385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878804207"/>
                  </a:ext>
                </a:extLst>
              </a:tr>
              <a:tr h="146733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ryptococcus neoformans</a:t>
                      </a:r>
                    </a:p>
                  </a:txBody>
                  <a:tcPr marL="3858" marR="3858" marT="385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JEC21</a:t>
                      </a:r>
                    </a:p>
                  </a:txBody>
                  <a:tcPr marL="3858" marR="3858" marT="385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hromosome</a:t>
                      </a:r>
                    </a:p>
                  </a:txBody>
                  <a:tcPr marL="3858" marR="3858" marT="385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CA_000091045.1</a:t>
                      </a:r>
                    </a:p>
                  </a:txBody>
                  <a:tcPr marL="3858" marR="3858" marT="385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CA_000091045.1_ASM9104v1_genomic.fna.gz</a:t>
                      </a:r>
                    </a:p>
                  </a:txBody>
                  <a:tcPr marL="3858" marR="3858" marT="385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3858" marR="3858" marT="385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094217715"/>
                  </a:ext>
                </a:extLst>
              </a:tr>
              <a:tr h="146733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ryptococcus neoformans</a:t>
                      </a:r>
                    </a:p>
                  </a:txBody>
                  <a:tcPr marL="3858" marR="3858" marT="385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B-3501A</a:t>
                      </a:r>
                    </a:p>
                  </a:txBody>
                  <a:tcPr marL="3858" marR="3858" marT="385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hromosome</a:t>
                      </a:r>
                    </a:p>
                  </a:txBody>
                  <a:tcPr marL="3858" marR="3858" marT="385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CF_000149385.1</a:t>
                      </a:r>
                    </a:p>
                  </a:txBody>
                  <a:tcPr marL="3858" marR="3858" marT="385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CF_000149385.1_ASM14938v1_genomic.fna.gz</a:t>
                      </a:r>
                    </a:p>
                  </a:txBody>
                  <a:tcPr marL="3858" marR="3858" marT="385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3858" marR="3858" marT="385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84439674"/>
                  </a:ext>
                </a:extLst>
              </a:tr>
              <a:tr h="146733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ryptococcus neoformans</a:t>
                      </a:r>
                    </a:p>
                  </a:txBody>
                  <a:tcPr marL="3858" marR="3858" marT="385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99</a:t>
                      </a:r>
                    </a:p>
                  </a:txBody>
                  <a:tcPr marL="3858" marR="3858" marT="385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hromosome</a:t>
                      </a:r>
                    </a:p>
                  </a:txBody>
                  <a:tcPr marL="3858" marR="3858" marT="385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CF_000149245.1</a:t>
                      </a:r>
                    </a:p>
                  </a:txBody>
                  <a:tcPr marL="3858" marR="3858" marT="385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CF_000149245.1_CNA3_genomic.fna.gz</a:t>
                      </a:r>
                    </a:p>
                  </a:txBody>
                  <a:tcPr marL="3858" marR="3858" marT="385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3858" marR="3858" marT="385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576287723"/>
                  </a:ext>
                </a:extLst>
              </a:tr>
              <a:tr h="146733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yberlindnera</a:t>
                      </a:r>
                    </a:p>
                  </a:txBody>
                  <a:tcPr marL="3858" marR="3858" marT="385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yberlindnera jadinii</a:t>
                      </a:r>
                    </a:p>
                  </a:txBody>
                  <a:tcPr marL="3858" marR="3858" marT="385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BRC0988</a:t>
                      </a:r>
                    </a:p>
                  </a:txBody>
                  <a:tcPr marL="3858" marR="3858" marT="385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hromosome</a:t>
                      </a:r>
                    </a:p>
                  </a:txBody>
                  <a:tcPr marL="3858" marR="3858" marT="385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CA_000328385.1</a:t>
                      </a:r>
                    </a:p>
                  </a:txBody>
                  <a:tcPr marL="3858" marR="3858" marT="385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CA_000328385.1_Cuti_1.0_genomic.fna.gz</a:t>
                      </a:r>
                    </a:p>
                  </a:txBody>
                  <a:tcPr marL="3858" marR="3858" marT="385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3858" marR="3858" marT="385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165949123"/>
                  </a:ext>
                </a:extLst>
              </a:tr>
              <a:tr h="146733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Debaryomyces</a:t>
                      </a:r>
                    </a:p>
                  </a:txBody>
                  <a:tcPr marL="3858" marR="3858" marT="385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Debaryomyces hansenii</a:t>
                      </a:r>
                    </a:p>
                  </a:txBody>
                  <a:tcPr marL="3858" marR="3858" marT="385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BS767</a:t>
                      </a:r>
                    </a:p>
                  </a:txBody>
                  <a:tcPr marL="3858" marR="3858" marT="385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hromosome</a:t>
                      </a:r>
                    </a:p>
                  </a:txBody>
                  <a:tcPr marL="3858" marR="3858" marT="385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CF_000006445.2</a:t>
                      </a:r>
                    </a:p>
                  </a:txBody>
                  <a:tcPr marL="3858" marR="3858" marT="385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CF_000006445.2_ASM644v2_genomic.fna.gz</a:t>
                      </a:r>
                    </a:p>
                  </a:txBody>
                  <a:tcPr marL="3858" marR="3858" marT="385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3858" marR="3858" marT="385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089931894"/>
                  </a:ext>
                </a:extLst>
              </a:tr>
              <a:tr h="146733">
                <a:tc rowSpan="2"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eotrichum</a:t>
                      </a:r>
                    </a:p>
                  </a:txBody>
                  <a:tcPr marL="3858" marR="3858" marT="385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Geotrichum candidum</a:t>
                      </a:r>
                    </a:p>
                  </a:txBody>
                  <a:tcPr marL="3858" marR="3858" marT="385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LIB 918</a:t>
                      </a:r>
                    </a:p>
                  </a:txBody>
                  <a:tcPr marL="3858" marR="3858" marT="385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caffold</a:t>
                      </a:r>
                    </a:p>
                  </a:txBody>
                  <a:tcPr marL="3858" marR="3858" marT="385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CA_001402995.1</a:t>
                      </a:r>
                    </a:p>
                  </a:txBody>
                  <a:tcPr marL="3858" marR="3858" marT="385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CA_001402995.1_New2.3_08062011_genomic.fna.gz</a:t>
                      </a:r>
                    </a:p>
                  </a:txBody>
                  <a:tcPr marL="3858" marR="3858" marT="385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3858" marR="3858" marT="385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834830854"/>
                  </a:ext>
                </a:extLst>
              </a:tr>
              <a:tr h="146733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Geotrichum fermentans</a:t>
                      </a:r>
                    </a:p>
                  </a:txBody>
                  <a:tcPr marL="3858" marR="3858" marT="385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ICC 1368</a:t>
                      </a:r>
                    </a:p>
                  </a:txBody>
                  <a:tcPr marL="3858" marR="3858" marT="385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caffold</a:t>
                      </a:r>
                    </a:p>
                  </a:txBody>
                  <a:tcPr marL="3858" marR="3858" marT="385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CA_002233575.1</a:t>
                      </a:r>
                    </a:p>
                  </a:txBody>
                  <a:tcPr marL="3858" marR="3858" marT="385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CA_002233575.1_ASM223357v1_genomic.fna.gz</a:t>
                      </a:r>
                    </a:p>
                  </a:txBody>
                  <a:tcPr marL="3858" marR="3858" marT="385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3858" marR="3858" marT="385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159659581"/>
                  </a:ext>
                </a:extLst>
              </a:tr>
              <a:tr h="146733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Kluyveromyces</a:t>
                      </a:r>
                    </a:p>
                  </a:txBody>
                  <a:tcPr marL="3858" marR="3858" marT="385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Kluyveromyces marxianus</a:t>
                      </a:r>
                    </a:p>
                  </a:txBody>
                  <a:tcPr marL="3858" marR="3858" marT="385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DMKU3-1042</a:t>
                      </a:r>
                    </a:p>
                  </a:txBody>
                  <a:tcPr marL="3858" marR="3858" marT="385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omplete Genome</a:t>
                      </a:r>
                    </a:p>
                  </a:txBody>
                  <a:tcPr marL="3858" marR="3858" marT="385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CF_001417885.1</a:t>
                      </a:r>
                    </a:p>
                  </a:txBody>
                  <a:tcPr marL="3858" marR="3858" marT="385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CF_001417885.1_Kmar_1.0_genomic.fna.gz</a:t>
                      </a:r>
                    </a:p>
                  </a:txBody>
                  <a:tcPr marL="3858" marR="3858" marT="385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3858" marR="3858" marT="385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278637374"/>
                  </a:ext>
                </a:extLst>
              </a:tr>
              <a:tr h="146733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Kodamaea</a:t>
                      </a:r>
                    </a:p>
                  </a:txBody>
                  <a:tcPr marL="3858" marR="3858" marT="385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Kodamaea ohmeri</a:t>
                      </a:r>
                    </a:p>
                  </a:txBody>
                  <a:tcPr marL="3858" marR="3858" marT="385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48</a:t>
                      </a:r>
                    </a:p>
                  </a:txBody>
                  <a:tcPr marL="3858" marR="3858" marT="385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ontig</a:t>
                      </a:r>
                    </a:p>
                  </a:txBody>
                  <a:tcPr marL="3858" marR="3858" marT="385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CA_004919595.1</a:t>
                      </a:r>
                    </a:p>
                  </a:txBody>
                  <a:tcPr marL="3858" marR="3858" marT="385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CA_004919595.1_Kodohm_148_genomic.fna.gz</a:t>
                      </a:r>
                    </a:p>
                  </a:txBody>
                  <a:tcPr marL="3858" marR="3858" marT="385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3858" marR="3858" marT="385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801660237"/>
                  </a:ext>
                </a:extLst>
              </a:tr>
              <a:tr h="146733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Lomentospora</a:t>
                      </a:r>
                    </a:p>
                  </a:txBody>
                  <a:tcPr marL="3858" marR="3858" marT="385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Lomentospora prolificans</a:t>
                      </a:r>
                    </a:p>
                  </a:txBody>
                  <a:tcPr marL="3858" marR="3858" marT="385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JHH-5317</a:t>
                      </a:r>
                    </a:p>
                  </a:txBody>
                  <a:tcPr marL="3858" marR="3858" marT="385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ontig</a:t>
                      </a:r>
                    </a:p>
                  </a:txBody>
                  <a:tcPr marL="3858" marR="3858" marT="385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CA_002276285.1</a:t>
                      </a:r>
                    </a:p>
                  </a:txBody>
                  <a:tcPr marL="3858" marR="3858" marT="385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CA_002276285.1_Lprolificans_pilon_genomic.fna.gz</a:t>
                      </a:r>
                    </a:p>
                  </a:txBody>
                  <a:tcPr marL="3858" marR="3858" marT="385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3858" marR="3858" marT="385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961708736"/>
                  </a:ext>
                </a:extLst>
              </a:tr>
              <a:tr h="146733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agnusiomyces</a:t>
                      </a:r>
                    </a:p>
                  </a:txBody>
                  <a:tcPr marL="3858" marR="3858" marT="385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agnusiomyces capitatus</a:t>
                      </a:r>
                    </a:p>
                  </a:txBody>
                  <a:tcPr marL="3858" marR="3858" marT="385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RRL Y-17686</a:t>
                      </a:r>
                    </a:p>
                  </a:txBody>
                  <a:tcPr marL="3858" marR="3858" marT="385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ontig</a:t>
                      </a:r>
                    </a:p>
                  </a:txBody>
                  <a:tcPr marL="3858" marR="3858" marT="385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CA_900497725.1</a:t>
                      </a:r>
                    </a:p>
                  </a:txBody>
                  <a:tcPr marL="3858" marR="3858" marT="385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CA_900497725.1_magCapA_genomic.fna.gz</a:t>
                      </a:r>
                    </a:p>
                  </a:txBody>
                  <a:tcPr marL="3858" marR="3858" marT="385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3858" marR="3858" marT="385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105193898"/>
                  </a:ext>
                </a:extLst>
              </a:tr>
              <a:tr h="146733">
                <a:tc rowSpan="2"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eyerozyma</a:t>
                      </a:r>
                    </a:p>
                  </a:txBody>
                  <a:tcPr marL="3858" marR="3858" marT="385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Meyerozyma caribbica</a:t>
                      </a:r>
                    </a:p>
                  </a:txBody>
                  <a:tcPr marL="3858" marR="3858" marT="385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G20W</a:t>
                      </a:r>
                    </a:p>
                  </a:txBody>
                  <a:tcPr marL="3858" marR="3858" marT="385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ontig</a:t>
                      </a:r>
                    </a:p>
                  </a:txBody>
                  <a:tcPr marL="3858" marR="3858" marT="385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CA_000755205.1</a:t>
                      </a:r>
                    </a:p>
                  </a:txBody>
                  <a:tcPr marL="3858" marR="3858" marT="385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CA_000755205.1_ASM75520v1_genomic.fna.gz</a:t>
                      </a:r>
                    </a:p>
                  </a:txBody>
                  <a:tcPr marL="3858" marR="3858" marT="385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3858" marR="3858" marT="385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217926465"/>
                  </a:ext>
                </a:extLst>
              </a:tr>
              <a:tr h="146733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Meyerozyma guilliermondii</a:t>
                      </a:r>
                    </a:p>
                  </a:txBody>
                  <a:tcPr marL="3858" marR="3858" marT="385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TCC 6260</a:t>
                      </a:r>
                    </a:p>
                  </a:txBody>
                  <a:tcPr marL="3858" marR="3858" marT="385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caffold</a:t>
                      </a:r>
                    </a:p>
                  </a:txBody>
                  <a:tcPr marL="3858" marR="3858" marT="385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CF_000149425.1</a:t>
                      </a:r>
                    </a:p>
                  </a:txBody>
                  <a:tcPr marL="3858" marR="3858" marT="385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CF_000149425.1_ASM14942v1_genomic.fna.gz</a:t>
                      </a:r>
                    </a:p>
                  </a:txBody>
                  <a:tcPr marL="3858" marR="3858" marT="385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3858" marR="3858" marT="385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831753735"/>
                  </a:ext>
                </a:extLst>
              </a:tr>
              <a:tr h="146733">
                <a:tc rowSpan="3"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ichia</a:t>
                      </a:r>
                    </a:p>
                  </a:txBody>
                  <a:tcPr marL="3858" marR="3858" marT="385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ichia kudriavzevii</a:t>
                      </a:r>
                    </a:p>
                  </a:txBody>
                  <a:tcPr marL="3858" marR="3858" marT="385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BS573</a:t>
                      </a:r>
                    </a:p>
                  </a:txBody>
                  <a:tcPr marL="3858" marR="3858" marT="385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omplete Genome</a:t>
                      </a:r>
                    </a:p>
                  </a:txBody>
                  <a:tcPr marL="3858" marR="3858" marT="385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CA_003054445.1</a:t>
                      </a:r>
                    </a:p>
                  </a:txBody>
                  <a:tcPr marL="3858" marR="3858" marT="385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CA_003054445.1_ASM305444v1_genomic.fna.gz</a:t>
                      </a:r>
                    </a:p>
                  </a:txBody>
                  <a:tcPr marL="3858" marR="3858" marT="385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3858" marR="3858" marT="385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552865808"/>
                  </a:ext>
                </a:extLst>
              </a:tr>
              <a:tr h="146733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ichia membranifaciens</a:t>
                      </a:r>
                    </a:p>
                  </a:txBody>
                  <a:tcPr marL="3858" marR="3858" marT="385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RRL Y-2026</a:t>
                      </a:r>
                    </a:p>
                  </a:txBody>
                  <a:tcPr marL="3858" marR="3858" marT="385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caffold</a:t>
                      </a:r>
                    </a:p>
                  </a:txBody>
                  <a:tcPr marL="3858" marR="3858" marT="385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CF_001661235.1</a:t>
                      </a:r>
                    </a:p>
                  </a:txBody>
                  <a:tcPr marL="3858" marR="3858" marT="385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CF_001661235.1_Picme2_genomic.fna.gz</a:t>
                      </a:r>
                    </a:p>
                  </a:txBody>
                  <a:tcPr marL="3858" marR="3858" marT="385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3858" marR="3858" marT="385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722786398"/>
                  </a:ext>
                </a:extLst>
              </a:tr>
              <a:tr h="146733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ichia norvegensis</a:t>
                      </a:r>
                    </a:p>
                  </a:txBody>
                  <a:tcPr marL="3858" marR="3858" marT="385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RRL Y-7687</a:t>
                      </a:r>
                    </a:p>
                  </a:txBody>
                  <a:tcPr marL="3858" marR="3858" marT="385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caffold</a:t>
                      </a:r>
                    </a:p>
                  </a:txBody>
                  <a:tcPr marL="3858" marR="3858" marT="385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CA_003705465.1</a:t>
                      </a:r>
                    </a:p>
                  </a:txBody>
                  <a:tcPr marL="3858" marR="3858" marT="385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CA_003705465.1_ASM370546v1_genomic.fna.gz</a:t>
                      </a:r>
                    </a:p>
                  </a:txBody>
                  <a:tcPr marL="3858" marR="3858" marT="385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3858" marR="3858" marT="385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101844292"/>
                  </a:ext>
                </a:extLst>
              </a:tr>
              <a:tr h="146733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urpureocillium</a:t>
                      </a:r>
                    </a:p>
                  </a:txBody>
                  <a:tcPr marL="3858" marR="3858" marT="385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urpureocillium lilacinum</a:t>
                      </a:r>
                    </a:p>
                  </a:txBody>
                  <a:tcPr marL="3858" marR="3858" marT="385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LFJ-1</a:t>
                      </a:r>
                    </a:p>
                  </a:txBody>
                  <a:tcPr marL="3858" marR="3858" marT="385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3858" marR="3858" marT="385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CA_004026455.1</a:t>
                      </a:r>
                    </a:p>
                  </a:txBody>
                  <a:tcPr marL="3858" marR="3858" marT="385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CA_004026455.1_ASM402645v1_genomic.fna</a:t>
                      </a:r>
                    </a:p>
                  </a:txBody>
                  <a:tcPr marL="3858" marR="3858" marT="385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ontamination species</a:t>
                      </a:r>
                    </a:p>
                  </a:txBody>
                  <a:tcPr marL="3858" marR="3858" marT="385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737873039"/>
                  </a:ext>
                </a:extLst>
              </a:tr>
              <a:tr h="146733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Rhodotorula</a:t>
                      </a:r>
                    </a:p>
                  </a:txBody>
                  <a:tcPr marL="3858" marR="3858" marT="385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Rhodotorula mucilaginosa</a:t>
                      </a:r>
                    </a:p>
                  </a:txBody>
                  <a:tcPr marL="3858" marR="3858" marT="385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RIT389</a:t>
                      </a:r>
                    </a:p>
                  </a:txBody>
                  <a:tcPr marL="3858" marR="3858" marT="385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ontig</a:t>
                      </a:r>
                    </a:p>
                  </a:txBody>
                  <a:tcPr marL="3858" marR="3858" marT="385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CA_002250355.1</a:t>
                      </a:r>
                    </a:p>
                  </a:txBody>
                  <a:tcPr marL="3858" marR="3858" marT="385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CA_002250355.1_RIT389_v1_genomic.fna.gz</a:t>
                      </a:r>
                    </a:p>
                  </a:txBody>
                  <a:tcPr marL="3858" marR="3858" marT="385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3858" marR="3858" marT="385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110667197"/>
                  </a:ext>
                </a:extLst>
              </a:tr>
              <a:tr h="146733">
                <a:tc rowSpan="2"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cedosporium</a:t>
                      </a:r>
                    </a:p>
                  </a:txBody>
                  <a:tcPr marL="3858" marR="3858" marT="385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cedosporium aurantiacum</a:t>
                      </a:r>
                    </a:p>
                  </a:txBody>
                  <a:tcPr marL="3858" marR="3858" marT="385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WM 09.24</a:t>
                      </a:r>
                    </a:p>
                  </a:txBody>
                  <a:tcPr marL="3858" marR="3858" marT="385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caffold</a:t>
                      </a:r>
                    </a:p>
                  </a:txBody>
                  <a:tcPr marL="3858" marR="3858" marT="385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CA_000812075.1</a:t>
                      </a:r>
                    </a:p>
                  </a:txBody>
                  <a:tcPr marL="3858" marR="3858" marT="385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CA_000812075.1_ASM81207v1_genomic.fna.gz</a:t>
                      </a:r>
                    </a:p>
                  </a:txBody>
                  <a:tcPr marL="3858" marR="3858" marT="385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3858" marR="3858" marT="385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12786689"/>
                  </a:ext>
                </a:extLst>
              </a:tr>
              <a:tr h="146733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cedosporium boydii</a:t>
                      </a:r>
                    </a:p>
                  </a:txBody>
                  <a:tcPr marL="3858" marR="3858" marT="385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IHEM 23826</a:t>
                      </a:r>
                    </a:p>
                  </a:txBody>
                  <a:tcPr marL="3858" marR="3858" marT="385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ontig</a:t>
                      </a:r>
                    </a:p>
                  </a:txBody>
                  <a:tcPr marL="3858" marR="3858" marT="385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CA_002221725.1</a:t>
                      </a:r>
                    </a:p>
                  </a:txBody>
                  <a:tcPr marL="3858" marR="3858" marT="385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CA_002221725.1_ScBoyd1.0_genomic.fna.gz</a:t>
                      </a:r>
                    </a:p>
                  </a:txBody>
                  <a:tcPr marL="3858" marR="3858" marT="385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3858" marR="3858" marT="385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851758337"/>
                  </a:ext>
                </a:extLst>
              </a:tr>
              <a:tr h="146733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richophyton</a:t>
                      </a:r>
                    </a:p>
                  </a:txBody>
                  <a:tcPr marL="3858" marR="3858" marT="385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Trichophyton rubrum</a:t>
                      </a:r>
                    </a:p>
                  </a:txBody>
                  <a:tcPr marL="3858" marR="3858" marT="385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BS 118892</a:t>
                      </a:r>
                    </a:p>
                  </a:txBody>
                  <a:tcPr marL="3858" marR="3858" marT="385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caffold</a:t>
                      </a:r>
                    </a:p>
                  </a:txBody>
                  <a:tcPr marL="3858" marR="3858" marT="385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CF_000151425.1</a:t>
                      </a:r>
                    </a:p>
                  </a:txBody>
                  <a:tcPr marL="3858" marR="3858" marT="385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CF_000151425.1_ASM15142v1_genomic.fna.gz</a:t>
                      </a:r>
                    </a:p>
                  </a:txBody>
                  <a:tcPr marL="3858" marR="3858" marT="385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3858" marR="3858" marT="385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766247276"/>
                  </a:ext>
                </a:extLst>
              </a:tr>
              <a:tr h="146733">
                <a:tc rowSpan="2"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richosporon</a:t>
                      </a:r>
                    </a:p>
                  </a:txBody>
                  <a:tcPr marL="3858" marR="3858" marT="385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Trichosporon asahii</a:t>
                      </a:r>
                    </a:p>
                  </a:txBody>
                  <a:tcPr marL="3858" marR="3858" marT="385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BS 2479</a:t>
                      </a:r>
                    </a:p>
                  </a:txBody>
                  <a:tcPr marL="3858" marR="3858" marT="385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caffold</a:t>
                      </a:r>
                    </a:p>
                  </a:txBody>
                  <a:tcPr marL="3858" marR="3858" marT="385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CF_000293215.1</a:t>
                      </a:r>
                    </a:p>
                  </a:txBody>
                  <a:tcPr marL="3858" marR="3858" marT="385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CF_000293215.1_Trichosporon_asahii_1_genomic.fna.gz</a:t>
                      </a:r>
                    </a:p>
                  </a:txBody>
                  <a:tcPr marL="3858" marR="3858" marT="385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3858" marR="3858" marT="385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931800589"/>
                  </a:ext>
                </a:extLst>
              </a:tr>
              <a:tr h="289608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Trichosporon dermatis</a:t>
                      </a:r>
                    </a:p>
                  </a:txBody>
                  <a:tcPr marL="3858" marR="3858" marT="385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JCM 11170</a:t>
                      </a:r>
                    </a:p>
                  </a:txBody>
                  <a:tcPr marL="3858" marR="3858" marT="385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caffold</a:t>
                      </a:r>
                    </a:p>
                  </a:txBody>
                  <a:tcPr marL="3858" marR="3858" marT="385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CA_003116895.1</a:t>
                      </a:r>
                    </a:p>
                  </a:txBody>
                  <a:tcPr marL="3858" marR="3858" marT="385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CA_003116895.1_JCM_11170_assembly_v001_genomic.fna.gz</a:t>
                      </a:r>
                    </a:p>
                  </a:txBody>
                  <a:tcPr marL="3858" marR="3858" marT="385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3858" marR="3858" marT="385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41372398"/>
                  </a:ext>
                </a:extLst>
              </a:tr>
              <a:tr h="146733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Wickerhamomyces</a:t>
                      </a:r>
                    </a:p>
                  </a:txBody>
                  <a:tcPr marL="3858" marR="3858" marT="385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Wickerhamomyces anomalus</a:t>
                      </a:r>
                    </a:p>
                  </a:txBody>
                  <a:tcPr marL="3858" marR="3858" marT="385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RRL Y-366-8</a:t>
                      </a:r>
                    </a:p>
                  </a:txBody>
                  <a:tcPr marL="3858" marR="3858" marT="385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caffold</a:t>
                      </a:r>
                    </a:p>
                  </a:txBody>
                  <a:tcPr marL="3858" marR="3858" marT="385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CF_001661255.1</a:t>
                      </a:r>
                    </a:p>
                  </a:txBody>
                  <a:tcPr marL="3858" marR="3858" marT="385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CF_001661255.1_Wican1_genomic.fna.gz</a:t>
                      </a:r>
                    </a:p>
                  </a:txBody>
                  <a:tcPr marL="3858" marR="3858" marT="385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3858" marR="3858" marT="385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355297250"/>
                  </a:ext>
                </a:extLst>
              </a:tr>
              <a:tr h="146733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Yarrowia</a:t>
                      </a:r>
                    </a:p>
                  </a:txBody>
                  <a:tcPr marL="3858" marR="3858" marT="385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Yarrowia lipolytica</a:t>
                      </a:r>
                    </a:p>
                  </a:txBody>
                  <a:tcPr marL="3858" marR="3858" marT="385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LIB122</a:t>
                      </a:r>
                    </a:p>
                  </a:txBody>
                  <a:tcPr marL="3858" marR="3858" marT="385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hromosome</a:t>
                      </a:r>
                    </a:p>
                  </a:txBody>
                  <a:tcPr marL="3858" marR="3858" marT="385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CF_000002525.2</a:t>
                      </a:r>
                    </a:p>
                  </a:txBody>
                  <a:tcPr marL="3858" marR="3858" marT="385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CF_000002525.2_ASM252v1_genomic.fna.gz</a:t>
                      </a:r>
                    </a:p>
                  </a:txBody>
                  <a:tcPr marL="3858" marR="3858" marT="385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3858" marR="3858" marT="385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69515336"/>
                  </a:ext>
                </a:extLst>
              </a:tr>
              <a:tr h="146733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Zygoascus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858" marR="3858" marT="385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Zygoascus</a:t>
                      </a: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 </a:t>
                      </a:r>
                      <a:r>
                        <a:rPr lang="en-US" sz="8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hellenicus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58" marR="3858" marT="385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Y-7136</a:t>
                      </a:r>
                    </a:p>
                  </a:txBody>
                  <a:tcPr marL="3858" marR="3858" marT="385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caffold</a:t>
                      </a:r>
                    </a:p>
                  </a:txBody>
                  <a:tcPr marL="3858" marR="3858" marT="385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3858" marR="3858" marT="385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Zyghe1_2_AssemblyScaffolds_Repeatmasked.fasta</a:t>
                      </a:r>
                    </a:p>
                  </a:txBody>
                  <a:tcPr marL="3858" marR="3858" marT="385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AU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o assembly from NCBI, downloaded from JGI, </a:t>
                      </a:r>
                      <a:r>
                        <a:rPr lang="en-AU" sz="9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axid</a:t>
                      </a:r>
                      <a:r>
                        <a:rPr lang="en-AU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5621</a:t>
                      </a:r>
                    </a:p>
                  </a:txBody>
                  <a:tcPr marL="3858" marR="3858" marT="385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532527284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196677191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/>
</p:properties>
</file>

<file path=customXml/item2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3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01EF7C38FBB09E4F85BDAAA01A857FC3" ma:contentTypeVersion="13" ma:contentTypeDescription="Create a new document." ma:contentTypeScope="" ma:versionID="462a9eb004de65fad2727f7b025d74ed">
  <xsd:schema xmlns:xsd="http://www.w3.org/2001/XMLSchema" xmlns:xs="http://www.w3.org/2001/XMLSchema" xmlns:p="http://schemas.microsoft.com/office/2006/metadata/properties" xmlns:ns3="a0cf5225-6064-4702-9e25-e106cea4ec30" xmlns:ns4="75e521d4-4013-45d9-ac7e-9eb842c0f228" targetNamespace="http://schemas.microsoft.com/office/2006/metadata/properties" ma:root="true" ma:fieldsID="385c780b75cbf956706aadcb38b7f192" ns3:_="" ns4:_="">
    <xsd:import namespace="a0cf5225-6064-4702-9e25-e106cea4ec30"/>
    <xsd:import namespace="75e521d4-4013-45d9-ac7e-9eb842c0f228"/>
    <xsd:element name="properties">
      <xsd:complexType>
        <xsd:sequence>
          <xsd:element name="documentManagement">
            <xsd:complexType>
              <xsd:all>
                <xsd:element ref="ns3:SharedWithUsers" minOccurs="0"/>
                <xsd:element ref="ns3:SharedWithDetails" minOccurs="0"/>
                <xsd:element ref="ns3:SharingHintHash" minOccurs="0"/>
                <xsd:element ref="ns4:MediaServiceMetadata" minOccurs="0"/>
                <xsd:element ref="ns4:MediaServiceFastMetadata" minOccurs="0"/>
                <xsd:element ref="ns4:MediaServiceAutoTags" minOccurs="0"/>
                <xsd:element ref="ns4:MediaServiceOCR" minOccurs="0"/>
                <xsd:element ref="ns4:MediaServiceAutoKeyPoints" minOccurs="0"/>
                <xsd:element ref="ns4:MediaServiceKeyPoints" minOccurs="0"/>
                <xsd:element ref="ns4:MediaServiceGenerationTime" minOccurs="0"/>
                <xsd:element ref="ns4:MediaServiceEventHashCode" minOccurs="0"/>
                <xsd:element ref="ns4:MediaServiceDateTaken" minOccurs="0"/>
                <xsd:element ref="ns4:MediaServiceLocation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a0cf5225-6064-4702-9e25-e106cea4ec30" elementFormDefault="qualified">
    <xsd:import namespace="http://schemas.microsoft.com/office/2006/documentManagement/types"/>
    <xsd:import namespace="http://schemas.microsoft.com/office/infopath/2007/PartnerControls"/>
    <xsd:element name="SharedWithUsers" ma:index="8" nillable="true" ma:displayName="Shared With" ma:internalName="SharedWithUsers" ma:readOnly="true">
      <xsd:complexType>
        <xsd:complexContent>
          <xsd:extension base="dms:UserMulti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  <xsd:element name="SharedWithDetails" ma:index="9" nillable="true" ma:displayName="Shared With Details" ma:internalName="SharedWithDetails" ma:readOnly="true">
      <xsd:simpleType>
        <xsd:restriction base="dms:Note">
          <xsd:maxLength value="255"/>
        </xsd:restriction>
      </xsd:simpleType>
    </xsd:element>
    <xsd:element name="SharingHintHash" ma:index="10" nillable="true" ma:displayName="Sharing Hint Hash" ma:hidden="true" ma:internalName="SharingHintHash" ma:readOnly="true">
      <xsd:simpleType>
        <xsd:restriction base="dms:Text"/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75e521d4-4013-45d9-ac7e-9eb842c0f228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11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12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AutoTags" ma:index="13" nillable="true" ma:displayName="MediaServiceAutoTags" ma:internalName="MediaServiceAutoTags" ma:readOnly="true">
      <xsd:simpleType>
        <xsd:restriction base="dms:Text"/>
      </xsd:simpleType>
    </xsd:element>
    <xsd:element name="MediaServiceOCR" ma:index="14" nillable="true" ma:displayName="MediaServiceOCR" ma:internalName="MediaServiceOCR" ma:readOnly="true">
      <xsd:simpleType>
        <xsd:restriction base="dms:Note">
          <xsd:maxLength value="255"/>
        </xsd:restriction>
      </xsd:simpleType>
    </xsd:element>
    <xsd:element name="MediaServiceAutoKeyPoints" ma:index="15" nillable="true" ma:displayName="MediaServiceAutoKeyPoints" ma:hidden="true" ma:internalName="MediaServiceAutoKeyPoints" ma:readOnly="true">
      <xsd:simpleType>
        <xsd:restriction base="dms:Note"/>
      </xsd:simpleType>
    </xsd:element>
    <xsd:element name="MediaServiceKeyPoints" ma:index="16" nillable="true" ma:displayName="KeyPoints" ma:internalName="MediaServiceKeyPoints" ma:readOnly="true">
      <xsd:simpleType>
        <xsd:restriction base="dms:Note">
          <xsd:maxLength value="255"/>
        </xsd:restriction>
      </xsd:simpleType>
    </xsd:element>
    <xsd:element name="MediaServiceGenerationTime" ma:index="17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8" nillable="true" ma:displayName="MediaServiceEventHashCode" ma:hidden="true" ma:internalName="MediaServiceEventHashCode" ma:readOnly="true">
      <xsd:simpleType>
        <xsd:restriction base="dms:Text"/>
      </xsd:simpleType>
    </xsd:element>
    <xsd:element name="MediaServiceDateTaken" ma:index="19" nillable="true" ma:displayName="MediaServiceDateTaken" ma:hidden="true" ma:internalName="MediaServiceDateTaken" ma:readOnly="true">
      <xsd:simpleType>
        <xsd:restriction base="dms:Text"/>
      </xsd:simpleType>
    </xsd:element>
    <xsd:element name="MediaServiceLocation" ma:index="20" nillable="true" ma:displayName="Location" ma:internalName="MediaServiceLocation" ma:readOnly="true">
      <xsd:simpleType>
        <xsd:restriction base="dms:Text"/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Props1.xml><?xml version="1.0" encoding="utf-8"?>
<ds:datastoreItem xmlns:ds="http://schemas.openxmlformats.org/officeDocument/2006/customXml" ds:itemID="{A5D643B9-32CB-4A57-8EB4-A25732E923B4}">
  <ds:schemaRefs>
    <ds:schemaRef ds:uri="http://schemas.microsoft.com/office/2006/documentManagement/types"/>
    <ds:schemaRef ds:uri="http://schemas.openxmlformats.org/package/2006/metadata/core-properties"/>
    <ds:schemaRef ds:uri="http://purl.org/dc/terms/"/>
    <ds:schemaRef ds:uri="http://schemas.microsoft.com/office/2006/metadata/properties"/>
    <ds:schemaRef ds:uri="http://purl.org/dc/elements/1.1/"/>
    <ds:schemaRef ds:uri="http://www.w3.org/XML/1998/namespace"/>
    <ds:schemaRef ds:uri="http://schemas.microsoft.com/office/infopath/2007/PartnerControls"/>
    <ds:schemaRef ds:uri="75e521d4-4013-45d9-ac7e-9eb842c0f228"/>
    <ds:schemaRef ds:uri="a0cf5225-6064-4702-9e25-e106cea4ec30"/>
    <ds:schemaRef ds:uri="http://purl.org/dc/dcmitype/"/>
  </ds:schemaRefs>
</ds:datastoreItem>
</file>

<file path=customXml/itemProps2.xml><?xml version="1.0" encoding="utf-8"?>
<ds:datastoreItem xmlns:ds="http://schemas.openxmlformats.org/officeDocument/2006/customXml" ds:itemID="{2D5F0301-31E9-4CA6-8393-3076A9C570F4}">
  <ds:schemaRefs>
    <ds:schemaRef ds:uri="http://schemas.microsoft.com/sharepoint/v3/contenttype/forms"/>
  </ds:schemaRefs>
</ds:datastoreItem>
</file>

<file path=customXml/itemProps3.xml><?xml version="1.0" encoding="utf-8"?>
<ds:datastoreItem xmlns:ds="http://schemas.openxmlformats.org/officeDocument/2006/customXml" ds:itemID="{8E1B70ED-758F-4DD0-9717-91AF3A883AEF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a0cf5225-6064-4702-9e25-e106cea4ec30"/>
    <ds:schemaRef ds:uri="75e521d4-4013-45d9-ac7e-9eb842c0f228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</TotalTime>
  <Words>400</Words>
  <Application>Microsoft Office PowerPoint</Application>
  <PresentationFormat>Custom</PresentationFormat>
  <Paragraphs>300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Yiheng Hu</dc:creator>
  <cp:lastModifiedBy>Yiheng Hu</cp:lastModifiedBy>
  <cp:revision>3</cp:revision>
  <dcterms:created xsi:type="dcterms:W3CDTF">2021-05-01T21:37:16Z</dcterms:created>
  <dcterms:modified xsi:type="dcterms:W3CDTF">2021-05-01T21:50:08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01EF7C38FBB09E4F85BDAAA01A857FC3</vt:lpwstr>
  </property>
</Properties>
</file>